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23" d="100"/>
          <a:sy n="123" d="100"/>
        </p:scale>
        <p:origin x="114" y="1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AA01D2-04CF-4D23-8261-4C11F62E0D37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F492C9-B74D-48F8-BA17-6F2CA385AF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31724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0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2478088" y="560388"/>
            <a:ext cx="4976812" cy="2800350"/>
          </a:xfrm>
          <a:ln/>
        </p:spPr>
      </p:sp>
      <p:sp>
        <p:nvSpPr>
          <p:cNvPr id="32771" name="ノート プレースホルダー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対象と方法です。</a:t>
            </a:r>
            <a:endParaRPr lang="en-US" altLang="ja-JP" dirty="0">
              <a:latin typeface="Arial" panose="020B0604020202020204" pitchFamily="34" charset="0"/>
              <a:ea typeface="ＭＳ Ｐ明朝" panose="02020600040205080304" pitchFamily="18" charset="-128"/>
            </a:endParaRPr>
          </a:p>
          <a:p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対象は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2006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年から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2019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年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5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月の間に　当院の心臓血管外科にて待機的開胸術を施行された患者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219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例のうち</a:t>
            </a:r>
            <a:endParaRPr lang="en-US" altLang="ja-JP" dirty="0">
              <a:latin typeface="Arial" panose="020B0604020202020204" pitchFamily="34" charset="0"/>
              <a:ea typeface="ＭＳ Ｐ明朝" panose="02020600040205080304" pitchFamily="18" charset="-128"/>
            </a:endParaRPr>
          </a:p>
          <a:p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除外症例のうち、片麻痺が残存するような明か</a:t>
            </a:r>
            <a:r>
              <a:rPr lang="ja-JP" altLang="en-US" dirty="0" err="1">
                <a:latin typeface="Arial" panose="020B0604020202020204" pitchFamily="34" charset="0"/>
                <a:ea typeface="ＭＳ Ｐ明朝" panose="02020600040205080304" pitchFamily="18" charset="-128"/>
              </a:rPr>
              <a:t>な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脳血管障害の既往を認めた症例が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2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例、頭頚部癌の手術の既往がある患者が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2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例、嚥下評価時点で経口摂取が開始されていなかった症例が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25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例、の計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29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例を除いた</a:t>
            </a:r>
            <a:endParaRPr lang="en-US" altLang="ja-JP" dirty="0">
              <a:latin typeface="Arial" panose="020B0604020202020204" pitchFamily="34" charset="0"/>
              <a:ea typeface="ＭＳ Ｐ明朝" panose="02020600040205080304" pitchFamily="18" charset="-128"/>
            </a:endParaRPr>
          </a:p>
          <a:p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計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190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例を対象に、診療記録から術後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1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週間の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FOIS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の情報を抽出し、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FOIS7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を非嚥下障害群、</a:t>
            </a:r>
            <a:r>
              <a:rPr lang="en-US" altLang="ja-JP" dirty="0">
                <a:latin typeface="Arial" panose="020B0604020202020204" pitchFamily="34" charset="0"/>
                <a:ea typeface="ＭＳ Ｐ明朝" panose="02020600040205080304" pitchFamily="18" charset="-128"/>
              </a:rPr>
              <a:t>FOIS2-6</a:t>
            </a:r>
            <a:r>
              <a:rPr lang="ja-JP" altLang="en-US" dirty="0">
                <a:latin typeface="Arial" panose="020B0604020202020204" pitchFamily="34" charset="0"/>
                <a:ea typeface="ＭＳ Ｐ明朝" panose="02020600040205080304" pitchFamily="18" charset="-128"/>
              </a:rPr>
              <a:t>を嚥下障害群とし、２群間における比較検討を行いました</a:t>
            </a:r>
            <a:endParaRPr lang="en-US" altLang="ja-JP" dirty="0">
              <a:latin typeface="Arial" panose="020B0604020202020204" pitchFamily="34" charset="0"/>
              <a:ea typeface="ＭＳ Ｐ明朝" panose="02020600040205080304" pitchFamily="18" charset="-128"/>
            </a:endParaRPr>
          </a:p>
        </p:txBody>
      </p:sp>
      <p:sp>
        <p:nvSpPr>
          <p:cNvPr id="32772" name="スライド番号プレースホルダー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9652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defTabSz="9652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defTabSz="9652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defTabSz="9652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defTabSz="9652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965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965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965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965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fld id="{A3B58723-6B9D-4A04-8D8B-8ED6A021315F}" type="slidenum">
              <a:rPr lang="en-US" altLang="ja-JP" smtClean="0"/>
              <a:pPr/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094138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27C862-5BFB-4E58-85C3-B491FAD6D9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ADCAE62-04FD-46B0-A774-5C2E88AD91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549916-071E-4EF6-AE4B-39726E5AA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2D125B-4424-4608-B1C3-9034E766F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373A906-9847-4EA1-8B22-9C5396650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3337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F9737B-3514-484A-A104-8E4A06F4E1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204080B-5D65-4616-9729-16BAFD0348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1C0C63-E8DA-4F14-8EA7-AD8AFDAB4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F618E1-A93C-4E16-A6A7-728897A49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092E93-EE60-4FAD-AD8C-963692885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93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C9B3CEB-092C-4F7A-84C2-08C92CD953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D2E01A5-D08E-4D08-960E-A9505937A2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D5E1F7-E215-4F07-A33C-71D153BC3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417BDB-9A1A-44D9-920D-6F15A667C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DBAC90-7495-4011-B161-7B1F727DA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817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E4944F-132F-45A1-B657-5001DA0B6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3261CE1-6BB9-46EC-B4F9-95357A9B5F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64D737-AED9-49F4-A986-C61851D2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993ABC-9323-40D7-A647-287F9515C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160EA3-D3A8-4A1B-9A65-1D678BFC03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9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D1F537-50C5-45AB-B7AC-A949E66550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A873553-9BD6-40DB-B2D1-39D11FDAF6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D75243-C994-4EF6-9E8E-584586FCC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85C6162-D08F-4936-98A0-34186611E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F9B64B-067C-4F2B-AD8D-7ED82F5F3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2428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B6771B-9EF3-4368-A565-55B9B9EF1E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81EF269-9707-471A-A7DD-A5A1DA27C1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D2951FE-DB71-45AF-8261-0632EB1D04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2F4E26-D285-4678-B3FF-7482F7D07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C742ED-060F-4DD0-B964-8CA4150BB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3B4D22F-FB95-4ED2-8CB0-A85C2613E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447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9EC596-9FEA-43B0-AB46-70ADE43CA8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9F67DC6-C011-48A2-B5BF-95CA03FC59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7E6544F-1D37-4073-8FDC-FFAE31DF3E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D11404E-EAF8-4408-9283-1F144B97DC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E6D9D5D-ABBD-44CB-B355-92AF98CF82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7DEC2F1-8D65-4082-AD66-B4AD1F87A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EF3ABD0-B157-4B3A-9815-3A51850AE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1D40EB3-971B-4516-BFD7-35A1D46CA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456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8FD79C-7980-4BA8-A7DA-3B4AF4F6D2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0E43EBF-2986-445A-AD31-198B3AA87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96D56B7-628D-49D2-AB97-2F23996B1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72C3C2D-1EA7-47D3-AB4F-4685E4FDB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1271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F7672A1-8328-48D2-9C63-385C91C6E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D57504B-723A-4C95-AE41-9302C44DC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783FFD4-5A56-4701-9330-B19E25F1F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989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9ECCEA-1F36-4565-BF09-9B86244FB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8316559-B5CB-414D-BAAD-2964415FB4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3BD12E8-AE99-44C2-89D3-251F191B46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2FF5B37-60D9-4CE4-89F1-56D5F5077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A1A8F48-866A-449C-98C4-CDD27C7F4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61C448F-A0DF-4783-A1C0-44F3AC78B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5437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B5C235-5A76-47FB-89B5-A1E683DBF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AFC7E33-D3D1-45AD-9E61-594491EDB7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8767D3E-EA70-47F9-ABD8-B042415488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27D4BB8-697C-4C7F-BA77-C49D1AFE0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011B077-948A-4300-B6FC-D13D57237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57DAC4A-BAE9-4264-AE18-90465EBCB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427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8CDA432-1573-4AE6-9AB0-9B9D1E2457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DF9E143-87AE-4310-98F0-72849BBD0D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01B540-24F4-44D4-A4C8-56AC336B19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03CECE-B424-40D7-9712-94387CDCDEA0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DA27F4-00E7-4FC9-B3B1-DF03353470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ADF393-1BE6-4EA0-95ED-32C12DA4B6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6C399-1332-43F8-A68F-DE9DC81ECA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7626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スライド番号プレースホルダー 3"/>
          <p:cNvSpPr>
            <a:spLocks noGrp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kumimoji="1" sz="2110">
                <a:solidFill>
                  <a:srgbClr val="4B4B4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83920" indent="-301508">
              <a:spcBef>
                <a:spcPct val="20000"/>
              </a:spcBef>
              <a:buChar char="–"/>
              <a:defRPr kumimoji="1" sz="2110">
                <a:solidFill>
                  <a:srgbClr val="4B4B4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206030" indent="-241206">
              <a:spcBef>
                <a:spcPct val="20000"/>
              </a:spcBef>
              <a:buChar char="•"/>
              <a:defRPr kumimoji="1" sz="2110">
                <a:solidFill>
                  <a:srgbClr val="4B4B4B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88442" indent="-241206">
              <a:spcBef>
                <a:spcPct val="20000"/>
              </a:spcBef>
              <a:buChar char="–"/>
              <a:defRPr kumimoji="1" sz="211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170855" indent="-241206">
              <a:spcBef>
                <a:spcPct val="20000"/>
              </a:spcBef>
              <a:buChar char="»"/>
              <a:defRPr kumimoji="1" sz="211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653267" indent="-241206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1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3135680" indent="-241206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1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618091" indent="-241206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1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4100504" indent="-241206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1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fld id="{14FAE395-3CFE-4718-9632-582397E29FAE}" type="slidenum">
              <a:rPr lang="en-US" altLang="ja-JP" sz="950"/>
              <a:pPr>
                <a:spcBef>
                  <a:spcPct val="0"/>
                </a:spcBef>
                <a:buFontTx/>
                <a:buNone/>
              </a:pPr>
              <a:t>1</a:t>
            </a:fld>
            <a:endParaRPr lang="en-US" altLang="ja-JP" sz="950"/>
          </a:p>
        </p:txBody>
      </p:sp>
      <p:grpSp>
        <p:nvGrpSpPr>
          <p:cNvPr id="31748" name="グループ化 4"/>
          <p:cNvGrpSpPr>
            <a:grpSpLocks/>
          </p:cNvGrpSpPr>
          <p:nvPr/>
        </p:nvGrpSpPr>
        <p:grpSpPr bwMode="auto">
          <a:xfrm>
            <a:off x="1712565" y="125690"/>
            <a:ext cx="9778646" cy="6052739"/>
            <a:chOff x="432087" y="266480"/>
            <a:chExt cx="9372364" cy="5991386"/>
          </a:xfrm>
        </p:grpSpPr>
        <p:sp>
          <p:nvSpPr>
            <p:cNvPr id="6" name="角丸四角形 5"/>
            <p:cNvSpPr/>
            <p:nvPr/>
          </p:nvSpPr>
          <p:spPr>
            <a:xfrm>
              <a:off x="625180" y="266480"/>
              <a:ext cx="4270727" cy="955097"/>
            </a:xfrm>
            <a:prstGeom prst="roundRect">
              <a:avLst/>
            </a:prstGeom>
            <a:noFill/>
            <a:ln w="28575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anchor="ctr"/>
            <a:lstStyle/>
            <a:p>
              <a:pPr algn="ctr" defTabSz="482412">
                <a:defRPr/>
              </a:pPr>
              <a:r>
                <a:rPr kumimoji="0" lang="en-US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184 patient older than 65 years who underwent elective cardiovascular surgery</a:t>
              </a:r>
              <a:endParaRPr kumimoji="0" lang="ja-JP" altLang="en-US" sz="1600" b="1" kern="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7" name="角丸四角形 6"/>
            <p:cNvSpPr/>
            <p:nvPr/>
          </p:nvSpPr>
          <p:spPr>
            <a:xfrm>
              <a:off x="3552471" y="1411144"/>
              <a:ext cx="6251980" cy="1724778"/>
            </a:xfrm>
            <a:prstGeom prst="roundRect">
              <a:avLst/>
            </a:prstGeom>
            <a:noFill/>
            <a:ln w="28575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anchor="ctr"/>
            <a:lstStyle/>
            <a:p>
              <a:pPr defTabSz="482412">
                <a:defRPr/>
              </a:pPr>
              <a:r>
                <a:rPr kumimoji="0" lang="en-US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Exclusion criteria</a:t>
              </a:r>
            </a:p>
            <a:p>
              <a:pPr marL="301508" indent="-301508" defTabSz="482412">
                <a:buFont typeface="Arial" panose="020B0604020202020204" pitchFamily="34" charset="0"/>
                <a:buChar char="•"/>
                <a:defRPr/>
              </a:pPr>
              <a:r>
                <a:rPr lang="en-US" altLang="ja-JP" sz="1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ith obvious cerebral infarction</a:t>
              </a:r>
              <a:r>
                <a:rPr kumimoji="0" lang="ja-JP" altLang="en-US" sz="1600" kern="0" dirty="0">
                  <a:effectLst/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kumimoji="0" lang="en-US" altLang="ja-JP" sz="1600" kern="0" dirty="0">
                  <a:effectLst/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(</a:t>
              </a:r>
              <a:r>
                <a:rPr kumimoji="0" lang="en-US" altLang="ja-JP" sz="1600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=4)</a:t>
              </a:r>
            </a:p>
            <a:p>
              <a:pPr marL="301508" indent="-301508" defTabSz="482412">
                <a:buFont typeface="Arial" panose="020B0604020202020204" pitchFamily="34" charset="0"/>
                <a:buChar char="•"/>
                <a:defRPr/>
              </a:pPr>
              <a:r>
                <a:rPr lang="en-US" altLang="ja-JP" sz="1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n a confused state (Richmond Agitation Sedation Scale </a:t>
              </a:r>
              <a:r>
                <a:rPr lang="en-US" altLang="ja-JP" sz="160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core of &lt;–</a:t>
              </a:r>
              <a:r>
                <a:rPr lang="en-US" altLang="ja-JP" sz="1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2 or &gt;+2) (</a:t>
              </a:r>
              <a:r>
                <a:rPr kumimoji="0" lang="en-US" altLang="ja-JP" sz="1600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=2)</a:t>
              </a:r>
            </a:p>
            <a:p>
              <a:pPr marL="301508" indent="-301508" defTabSz="482412">
                <a:buFont typeface="Arial" panose="020B0604020202020204" pitchFamily="34" charset="0"/>
                <a:buChar char="•"/>
                <a:defRPr/>
              </a:pPr>
              <a:r>
                <a:rPr lang="en-US" altLang="ja-JP" sz="1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ith level 1 postoperative FOIS (</a:t>
              </a:r>
              <a:r>
                <a:rPr kumimoji="0" lang="en-US" altLang="ja-JP" sz="1600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=24)</a:t>
              </a:r>
              <a:endParaRPr kumimoji="0" lang="ja-JP" altLang="en-US" sz="1600" kern="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8" name="角丸四角形 7">
              <a:extLst>
                <a:ext uri="{FF2B5EF4-FFF2-40B4-BE49-F238E27FC236}">
                  <a16:creationId xmlns:a16="http://schemas.microsoft.com/office/drawing/2014/main" id="{1B90A43B-07AF-A142-AD0A-59A0000BD019}"/>
                </a:ext>
              </a:extLst>
            </p:cNvPr>
            <p:cNvSpPr/>
            <p:nvPr/>
          </p:nvSpPr>
          <p:spPr>
            <a:xfrm>
              <a:off x="732618" y="3361888"/>
              <a:ext cx="4055849" cy="1321548"/>
            </a:xfrm>
            <a:prstGeom prst="roundRect">
              <a:avLst/>
            </a:prstGeom>
            <a:noFill/>
            <a:ln w="28575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anchor="ctr"/>
            <a:lstStyle/>
            <a:p>
              <a:pPr algn="ctr" defTabSz="482412">
                <a:defRPr/>
              </a:pPr>
              <a:r>
                <a:rPr kumimoji="0" lang="en-US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=154</a:t>
              </a:r>
            </a:p>
            <a:p>
              <a:pPr algn="ctr" defTabSz="482412">
                <a:defRPr/>
              </a:pPr>
              <a:r>
                <a:rPr kumimoji="0" lang="en-US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Severity of dysphagia </a:t>
              </a:r>
            </a:p>
            <a:p>
              <a:pPr marL="285750" indent="-285750" algn="ctr" defTabSz="482412">
                <a:buFont typeface="Arial" panose="020B0604020202020204" pitchFamily="34" charset="0"/>
                <a:buChar char="•"/>
                <a:defRPr/>
              </a:pPr>
              <a:r>
                <a:rPr kumimoji="0" lang="en-US" altLang="ja-JP" sz="1600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Within 2 week after surgery</a:t>
              </a:r>
            </a:p>
            <a:p>
              <a:pPr marL="285750" indent="-285750" algn="ctr" defTabSz="482412">
                <a:buFont typeface="Arial" panose="020B0604020202020204" pitchFamily="34" charset="0"/>
                <a:buChar char="•"/>
                <a:defRPr/>
              </a:pPr>
              <a:r>
                <a:rPr kumimoji="0" lang="en-US" altLang="ja-JP" sz="1600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FOIS</a:t>
              </a:r>
            </a:p>
          </p:txBody>
        </p:sp>
        <p:sp>
          <p:nvSpPr>
            <p:cNvPr id="9" name="角丸四角形 8"/>
            <p:cNvSpPr/>
            <p:nvPr/>
          </p:nvSpPr>
          <p:spPr>
            <a:xfrm>
              <a:off x="2891792" y="5261315"/>
              <a:ext cx="2070257" cy="996551"/>
            </a:xfrm>
            <a:prstGeom prst="roundRect">
              <a:avLst/>
            </a:prstGeom>
            <a:noFill/>
            <a:ln w="28575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anchor="ctr"/>
            <a:lstStyle/>
            <a:p>
              <a:pPr algn="ctr" defTabSz="482412">
                <a:defRPr/>
              </a:pPr>
              <a:r>
                <a:rPr kumimoji="0" lang="en-US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Dysphagia</a:t>
              </a:r>
              <a:r>
                <a:rPr kumimoji="0" lang="ja-JP" altLang="en-US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kumimoji="0" lang="en-US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group </a:t>
              </a:r>
              <a:r>
                <a:rPr kumimoji="0" lang="en-PH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(</a:t>
              </a:r>
              <a:r>
                <a:rPr kumimoji="0" lang="en-US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=13)</a:t>
              </a:r>
            </a:p>
            <a:p>
              <a:pPr algn="ctr" defTabSz="482412">
                <a:defRPr/>
              </a:pPr>
              <a:r>
                <a:rPr kumimoji="0" lang="en-US" altLang="ja-JP" sz="1600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FOIS levels 2-6</a:t>
              </a:r>
              <a:endParaRPr kumimoji="0" lang="ja-JP" altLang="en-US" sz="1600" kern="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10" name="角丸四角形 9"/>
            <p:cNvSpPr/>
            <p:nvPr/>
          </p:nvSpPr>
          <p:spPr>
            <a:xfrm>
              <a:off x="432087" y="5254680"/>
              <a:ext cx="2070257" cy="1003184"/>
            </a:xfrm>
            <a:prstGeom prst="roundRect">
              <a:avLst/>
            </a:prstGeom>
            <a:noFill/>
            <a:ln w="28575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anchor="ctr"/>
            <a:lstStyle/>
            <a:p>
              <a:pPr algn="ctr" defTabSz="482412">
                <a:defRPr/>
              </a:pPr>
              <a:r>
                <a:rPr kumimoji="0" lang="en-US" altLang="ja-JP" sz="1600" b="1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on-dysphagia group (n=141)</a:t>
              </a:r>
            </a:p>
            <a:p>
              <a:pPr algn="ctr" defTabSz="482412">
                <a:defRPr/>
              </a:pPr>
              <a:r>
                <a:rPr kumimoji="0" lang="en-US" altLang="ja-JP" sz="1600" kern="0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FOIS level 7</a:t>
              </a:r>
              <a:endParaRPr kumimoji="0" lang="ja-JP" altLang="en-US" sz="1600" kern="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cxnSp>
          <p:nvCxnSpPr>
            <p:cNvPr id="31754" name="直線コネクタ 10"/>
            <p:cNvCxnSpPr>
              <a:cxnSpLocks/>
            </p:cNvCxnSpPr>
            <p:nvPr/>
          </p:nvCxnSpPr>
          <p:spPr bwMode="auto">
            <a:xfrm flipH="1">
              <a:off x="2760543" y="1221577"/>
              <a:ext cx="72" cy="2138105"/>
            </a:xfrm>
            <a:prstGeom prst="line">
              <a:avLst/>
            </a:prstGeom>
            <a:noFill/>
            <a:ln w="28575" algn="ctr">
              <a:solidFill>
                <a:schemeClr val="tx1"/>
              </a:solidFill>
              <a:miter lim="800000"/>
              <a:headEnd/>
              <a:tailEnd/>
            </a:ln>
          </p:spPr>
        </p:cxnSp>
        <p:cxnSp>
          <p:nvCxnSpPr>
            <p:cNvPr id="31755" name="直線矢印コネクタ 11"/>
            <p:cNvCxnSpPr>
              <a:cxnSpLocks noChangeShapeType="1"/>
            </p:cNvCxnSpPr>
            <p:nvPr/>
          </p:nvCxnSpPr>
          <p:spPr bwMode="auto">
            <a:xfrm>
              <a:off x="2780740" y="2273533"/>
              <a:ext cx="792000" cy="0"/>
            </a:xfrm>
            <a:prstGeom prst="straightConnector1">
              <a:avLst/>
            </a:prstGeom>
            <a:noFill/>
            <a:ln w="28575" algn="ctr">
              <a:solidFill>
                <a:schemeClr val="tx1"/>
              </a:solidFill>
              <a:miter lim="800000"/>
              <a:headEnd/>
              <a:tailEnd type="triangle" w="lg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1756" name="直線矢印コネクタ 12"/>
            <p:cNvCxnSpPr>
              <a:cxnSpLocks noChangeShapeType="1"/>
            </p:cNvCxnSpPr>
            <p:nvPr/>
          </p:nvCxnSpPr>
          <p:spPr bwMode="auto">
            <a:xfrm>
              <a:off x="1610741" y="4987221"/>
              <a:ext cx="0" cy="252000"/>
            </a:xfrm>
            <a:prstGeom prst="straightConnector1">
              <a:avLst/>
            </a:prstGeom>
            <a:noFill/>
            <a:ln w="28575" algn="ctr">
              <a:solidFill>
                <a:schemeClr val="tx1"/>
              </a:solidFill>
              <a:miter lim="800000"/>
              <a:headEnd/>
              <a:tailEnd type="triangle" w="lg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1757" name="直線矢印コネクタ 13"/>
            <p:cNvCxnSpPr>
              <a:cxnSpLocks noChangeShapeType="1"/>
            </p:cNvCxnSpPr>
            <p:nvPr/>
          </p:nvCxnSpPr>
          <p:spPr bwMode="auto">
            <a:xfrm flipH="1">
              <a:off x="3950741" y="5003019"/>
              <a:ext cx="0" cy="252000"/>
            </a:xfrm>
            <a:prstGeom prst="straightConnector1">
              <a:avLst/>
            </a:prstGeom>
            <a:noFill/>
            <a:ln w="28575" algn="ctr">
              <a:solidFill>
                <a:schemeClr val="tx1"/>
              </a:solidFill>
              <a:miter lim="800000"/>
              <a:headEnd/>
              <a:tailEnd type="triangle" w="lg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1758" name="直線コネクタ 14"/>
            <p:cNvCxnSpPr>
              <a:cxnSpLocks/>
            </p:cNvCxnSpPr>
            <p:nvPr/>
          </p:nvCxnSpPr>
          <p:spPr bwMode="auto">
            <a:xfrm flipH="1" flipV="1">
              <a:off x="1610741" y="5003019"/>
              <a:ext cx="2340000" cy="0"/>
            </a:xfrm>
            <a:prstGeom prst="line">
              <a:avLst/>
            </a:prstGeom>
            <a:noFill/>
            <a:ln w="28575" algn="ctr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1759" name="直線コネクタ 15"/>
            <p:cNvCxnSpPr>
              <a:cxnSpLocks/>
            </p:cNvCxnSpPr>
            <p:nvPr/>
          </p:nvCxnSpPr>
          <p:spPr bwMode="auto">
            <a:xfrm flipH="1">
              <a:off x="2760543" y="4699227"/>
              <a:ext cx="0" cy="288000"/>
            </a:xfrm>
            <a:prstGeom prst="line">
              <a:avLst/>
            </a:prstGeom>
            <a:noFill/>
            <a:ln w="28575" algn="ctr">
              <a:solidFill>
                <a:schemeClr val="tx1"/>
              </a:solidFill>
              <a:miter lim="800000"/>
              <a:headEnd/>
              <a:tailEnd/>
            </a:ln>
          </p:spPr>
        </p:cxn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9E672A29-9B1B-5E91-FDC7-C186B33CDACD}"/>
              </a:ext>
            </a:extLst>
          </p:cNvPr>
          <p:cNvSpPr/>
          <p:nvPr/>
        </p:nvSpPr>
        <p:spPr>
          <a:xfrm>
            <a:off x="9363271" y="5936441"/>
            <a:ext cx="2355474" cy="7590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99"/>
          </a:p>
        </p:txBody>
      </p:sp>
    </p:spTree>
    <p:extLst>
      <p:ext uri="{BB962C8B-B14F-4D97-AF65-F5344CB8AC3E}">
        <p14:creationId xmlns:p14="http://schemas.microsoft.com/office/powerpoint/2010/main" val="1994440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223</Words>
  <Application>Microsoft Office PowerPoint</Application>
  <PresentationFormat>ワイド画面</PresentationFormat>
  <Paragraphs>1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城翠</dc:creator>
  <cp:lastModifiedBy>宮城翠</cp:lastModifiedBy>
  <cp:revision>13</cp:revision>
  <cp:lastPrinted>2023-09-22T08:09:09Z</cp:lastPrinted>
  <dcterms:created xsi:type="dcterms:W3CDTF">2023-09-14T09:29:07Z</dcterms:created>
  <dcterms:modified xsi:type="dcterms:W3CDTF">2023-09-28T06:13:57Z</dcterms:modified>
</cp:coreProperties>
</file>